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434" autoAdjust="0"/>
  </p:normalViewPr>
  <p:slideViewPr>
    <p:cSldViewPr snapToGrid="0">
      <p:cViewPr>
        <p:scale>
          <a:sx n="70" d="100"/>
          <a:sy n="70" d="100"/>
        </p:scale>
        <p:origin x="132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E63289-1F5E-4BE2-85C5-C831C43ABCEB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01E41F-D8C8-43E9-B3FF-C259CD17C0E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997679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6F900A-06E6-486D-8730-8EFE0433F940}" type="slidenum">
              <a:rPr lang="el-GR" smtClean="0"/>
              <a:t>1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889083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07136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67301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94255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35408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72067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93789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473566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15915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2963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115504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31324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6DEC07-A23A-4B02-BC0A-48124B80097D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1FDC11-19BC-48C6-9735-C57A8B03D58C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5708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- TextBox"/>
          <p:cNvSpPr txBox="1"/>
          <p:nvPr/>
        </p:nvSpPr>
        <p:spPr>
          <a:xfrm>
            <a:off x="1465843" y="4491915"/>
            <a:ext cx="91083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p=0.050</a:t>
            </a:r>
            <a:endParaRPr lang="el-GR" sz="15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38"/>
          <p:cNvSpPr txBox="1">
            <a:spLocks noChangeArrowheads="1"/>
          </p:cNvSpPr>
          <p:nvPr/>
        </p:nvSpPr>
        <p:spPr bwMode="auto">
          <a:xfrm>
            <a:off x="884347" y="5540833"/>
            <a:ext cx="41197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rIns="3600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spcAft>
                <a:spcPts val="1600"/>
              </a:spcAft>
              <a:buFontTx/>
              <a:buNone/>
            </a:pP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25         50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    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        12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</a:p>
        </p:txBody>
      </p:sp>
      <p:grpSp>
        <p:nvGrpSpPr>
          <p:cNvPr id="41" name="Group 40"/>
          <p:cNvGrpSpPr/>
          <p:nvPr/>
        </p:nvGrpSpPr>
        <p:grpSpPr>
          <a:xfrm>
            <a:off x="52046" y="1967991"/>
            <a:ext cx="4411647" cy="4053297"/>
            <a:chOff x="4421356" y="1008000"/>
            <a:chExt cx="4650708" cy="4240737"/>
          </a:xfrm>
        </p:grpSpPr>
        <p:grpSp>
          <p:nvGrpSpPr>
            <p:cNvPr id="38" name="Group 37"/>
            <p:cNvGrpSpPr/>
            <p:nvPr/>
          </p:nvGrpSpPr>
          <p:grpSpPr>
            <a:xfrm>
              <a:off x="4644000" y="1008000"/>
              <a:ext cx="4428064" cy="3825136"/>
              <a:chOff x="4644000" y="1008000"/>
              <a:chExt cx="4428064" cy="3825136"/>
            </a:xfrm>
          </p:grpSpPr>
          <p:cxnSp>
            <p:nvCxnSpPr>
              <p:cNvPr id="7" name="Straight Connector 6"/>
              <p:cNvCxnSpPr/>
              <p:nvPr/>
            </p:nvCxnSpPr>
            <p:spPr>
              <a:xfrm>
                <a:off x="5148000" y="1008000"/>
                <a:ext cx="0" cy="3636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5148064" y="4653136"/>
                <a:ext cx="3924000" cy="214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/>
              <p:cNvCxnSpPr/>
              <p:nvPr/>
            </p:nvCxnSpPr>
            <p:spPr>
              <a:xfrm flipH="1">
                <a:off x="4981546" y="1556792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 flipH="1">
                <a:off x="5004000" y="2132856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 flipH="1">
                <a:off x="4983541" y="2708920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 flipH="1">
                <a:off x="4968000" y="328498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 flipH="1">
                <a:off x="4983541" y="3861048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flipH="1">
                <a:off x="4983541" y="436510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 flipV="1">
                <a:off x="543609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 flipV="1">
                <a:off x="6084168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 flipV="1">
                <a:off x="6732240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 flipV="1">
                <a:off x="7380312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 flipV="1">
                <a:off x="8028384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flipV="1">
                <a:off x="867645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4644000" y="4212000"/>
                <a:ext cx="504000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644000" y="370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2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644000" y="3132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4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4644008" y="2574063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6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644000" y="1944000"/>
                <a:ext cx="504000" cy="360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8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4644000" y="136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9" name="TextBox 38"/>
            <p:cNvSpPr txBox="1"/>
            <p:nvPr/>
          </p:nvSpPr>
          <p:spPr>
            <a:xfrm>
              <a:off x="6084168" y="4925572"/>
              <a:ext cx="223224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of follow-up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421356" y="1008000"/>
              <a:ext cx="438013" cy="302271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gression-free survival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3" name="Group 72"/>
          <p:cNvGrpSpPr/>
          <p:nvPr/>
        </p:nvGrpSpPr>
        <p:grpSpPr>
          <a:xfrm>
            <a:off x="4499992" y="1463935"/>
            <a:ext cx="4464496" cy="4629361"/>
            <a:chOff x="4365643" y="427235"/>
            <a:chExt cx="4706421" cy="4843440"/>
          </a:xfrm>
        </p:grpSpPr>
        <p:grpSp>
          <p:nvGrpSpPr>
            <p:cNvPr id="74" name="Group 73"/>
            <p:cNvGrpSpPr/>
            <p:nvPr/>
          </p:nvGrpSpPr>
          <p:grpSpPr>
            <a:xfrm>
              <a:off x="4644000" y="1008000"/>
              <a:ext cx="4428064" cy="3825136"/>
              <a:chOff x="4644000" y="1008000"/>
              <a:chExt cx="4428064" cy="3825136"/>
            </a:xfrm>
          </p:grpSpPr>
          <p:cxnSp>
            <p:nvCxnSpPr>
              <p:cNvPr id="77" name="Straight Connector 76"/>
              <p:cNvCxnSpPr/>
              <p:nvPr/>
            </p:nvCxnSpPr>
            <p:spPr>
              <a:xfrm>
                <a:off x="5148000" y="1008000"/>
                <a:ext cx="0" cy="3636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5148064" y="4653136"/>
                <a:ext cx="3924000" cy="214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 flipH="1">
                <a:off x="4981546" y="1556792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 flipH="1">
                <a:off x="5004000" y="2132856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 flipH="1">
                <a:off x="4983541" y="2708920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 flipH="1">
                <a:off x="4968000" y="328498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 flipH="1">
                <a:off x="4983541" y="3861048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 flipH="1">
                <a:off x="4983541" y="436510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 flipV="1">
                <a:off x="543609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 flipV="1">
                <a:off x="6084168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 flipV="1">
                <a:off x="6732240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 flipV="1">
                <a:off x="7380312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 flipV="1">
                <a:off x="8028384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 flipV="1">
                <a:off x="867645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1" name="TextBox 90"/>
              <p:cNvSpPr txBox="1"/>
              <p:nvPr/>
            </p:nvSpPr>
            <p:spPr>
              <a:xfrm>
                <a:off x="4644000" y="4212000"/>
                <a:ext cx="504000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4644000" y="370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2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4644000" y="3132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4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4644008" y="2574063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6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4644000" y="1944000"/>
                <a:ext cx="504000" cy="360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8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4644000" y="136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5" name="TextBox 74"/>
            <p:cNvSpPr txBox="1"/>
            <p:nvPr/>
          </p:nvSpPr>
          <p:spPr>
            <a:xfrm>
              <a:off x="6084168" y="4947510"/>
              <a:ext cx="223224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of follow-up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365643" y="427235"/>
              <a:ext cx="438013" cy="302271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7" name="TextBox 38"/>
          <p:cNvSpPr txBox="1">
            <a:spLocks noChangeArrowheads="1"/>
          </p:cNvSpPr>
          <p:nvPr/>
        </p:nvSpPr>
        <p:spPr bwMode="auto">
          <a:xfrm>
            <a:off x="5364088" y="5568391"/>
            <a:ext cx="41197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rIns="3600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spcAft>
                <a:spcPts val="1600"/>
              </a:spcAft>
              <a:buFontTx/>
              <a:buNone/>
            </a:pP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          25         50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    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        12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</a:p>
        </p:txBody>
      </p:sp>
      <p:sp>
        <p:nvSpPr>
          <p:cNvPr id="100" name="9 - TextBox"/>
          <p:cNvSpPr txBox="1"/>
          <p:nvPr/>
        </p:nvSpPr>
        <p:spPr>
          <a:xfrm>
            <a:off x="5738077" y="4423066"/>
            <a:ext cx="91083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p=0.194</a:t>
            </a:r>
            <a:endParaRPr lang="el-GR" sz="15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67544" y="1196752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)</a:t>
            </a:r>
            <a:endParaRPr lang="el-GR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5240302" y="124861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r>
              <a:rPr lang="en-US" b="1" dirty="0" smtClean="0"/>
              <a:t>)</a:t>
            </a:r>
            <a:endParaRPr lang="el-GR" b="1" dirty="0"/>
          </a:p>
        </p:txBody>
      </p:sp>
      <p:pic>
        <p:nvPicPr>
          <p:cNvPr id="63" name="Picture 62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69" t="4065" r="28070" b="50136"/>
          <a:stretch/>
        </p:blipFill>
        <p:spPr bwMode="auto">
          <a:xfrm>
            <a:off x="916811" y="2280840"/>
            <a:ext cx="3724275" cy="160972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4" name="22 - TextBox"/>
          <p:cNvSpPr txBox="1"/>
          <p:nvPr/>
        </p:nvSpPr>
        <p:spPr>
          <a:xfrm>
            <a:off x="3423489" y="2856902"/>
            <a:ext cx="1768091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>
                <a:latin typeface="Times New Roman" pitchFamily="18" charset="0"/>
                <a:cs typeface="Times New Roman" pitchFamily="18" charset="0"/>
              </a:rPr>
              <a:t>LN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 (+),</a:t>
            </a:r>
            <a:r>
              <a:rPr lang="en-US" sz="75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750" i="1" dirty="0">
                <a:latin typeface="Times New Roman" pitchFamily="18" charset="0"/>
                <a:cs typeface="Times New Roman" pitchFamily="18" charset="0"/>
              </a:rPr>
              <a:t>TWIST1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75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sz="750" dirty="0">
                <a:latin typeface="Times New Roman" pitchFamily="18" charset="0"/>
                <a:cs typeface="Times New Roman" pitchFamily="18" charset="0"/>
              </a:rPr>
              <a:t> </a:t>
            </a:r>
            <a:endParaRPr lang="el-GR" sz="7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23 - TextBox"/>
          <p:cNvSpPr txBox="1"/>
          <p:nvPr/>
        </p:nvSpPr>
        <p:spPr>
          <a:xfrm>
            <a:off x="2756903" y="3153872"/>
            <a:ext cx="1768091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>
                <a:latin typeface="Times New Roman" pitchFamily="18" charset="0"/>
                <a:cs typeface="Times New Roman" pitchFamily="18" charset="0"/>
              </a:rPr>
              <a:t>LN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75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sz="75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750" i="1" dirty="0">
                <a:latin typeface="Times New Roman" pitchFamily="18" charset="0"/>
                <a:cs typeface="Times New Roman" pitchFamily="18" charset="0"/>
              </a:rPr>
              <a:t>TWIST1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(+)</a:t>
            </a:r>
          </a:p>
        </p:txBody>
      </p:sp>
      <p:sp>
        <p:nvSpPr>
          <p:cNvPr id="66" name="24 - TextBox"/>
          <p:cNvSpPr txBox="1"/>
          <p:nvPr/>
        </p:nvSpPr>
        <p:spPr>
          <a:xfrm>
            <a:off x="3722804" y="2576326"/>
            <a:ext cx="171451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>
                <a:latin typeface="Times New Roman" pitchFamily="18" charset="0"/>
                <a:cs typeface="Times New Roman" pitchFamily="18" charset="0"/>
              </a:rPr>
              <a:t>LN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75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sz="75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750" i="1" dirty="0">
                <a:latin typeface="Times New Roman" pitchFamily="18" charset="0"/>
                <a:cs typeface="Times New Roman" pitchFamily="18" charset="0"/>
              </a:rPr>
              <a:t>TWIST1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(-)</a:t>
            </a:r>
          </a:p>
        </p:txBody>
      </p:sp>
      <p:sp>
        <p:nvSpPr>
          <p:cNvPr id="67" name="22 - TextBox"/>
          <p:cNvSpPr txBox="1"/>
          <p:nvPr/>
        </p:nvSpPr>
        <p:spPr>
          <a:xfrm>
            <a:off x="3657190" y="3627360"/>
            <a:ext cx="155377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>
                <a:latin typeface="Times New Roman" pitchFamily="18" charset="0"/>
                <a:cs typeface="Times New Roman" pitchFamily="18" charset="0"/>
              </a:rPr>
              <a:t>LN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 (+)</a:t>
            </a:r>
            <a:r>
              <a:rPr lang="en-US" sz="75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750" i="1" dirty="0">
                <a:latin typeface="Times New Roman" pitchFamily="18" charset="0"/>
                <a:cs typeface="Times New Roman" pitchFamily="18" charset="0"/>
              </a:rPr>
              <a:t>TWIST1</a:t>
            </a:r>
            <a:r>
              <a:rPr lang="el-GR" sz="75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(+)</a:t>
            </a:r>
          </a:p>
          <a:p>
            <a:r>
              <a:rPr lang="en-US" sz="750" dirty="0">
                <a:latin typeface="Times New Roman" pitchFamily="18" charset="0"/>
                <a:cs typeface="Times New Roman" pitchFamily="18" charset="0"/>
              </a:rPr>
              <a:t> </a:t>
            </a:r>
            <a:endParaRPr lang="el-GR" sz="75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8" name="Picture 67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86" t="4878" r="29027" b="58537"/>
          <a:stretch/>
        </p:blipFill>
        <p:spPr bwMode="auto">
          <a:xfrm>
            <a:off x="5498496" y="2351993"/>
            <a:ext cx="3600450" cy="128587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9" name="24 - TextBox"/>
          <p:cNvSpPr txBox="1"/>
          <p:nvPr/>
        </p:nvSpPr>
        <p:spPr>
          <a:xfrm>
            <a:off x="8107232" y="2794251"/>
            <a:ext cx="171451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>
                <a:latin typeface="Times New Roman" pitchFamily="18" charset="0"/>
                <a:cs typeface="Times New Roman" pitchFamily="18" charset="0"/>
              </a:rPr>
              <a:t>LN(-), </a:t>
            </a:r>
            <a:r>
              <a:rPr lang="en-US" sz="750" i="1" dirty="0">
                <a:latin typeface="Times New Roman" pitchFamily="18" charset="0"/>
                <a:cs typeface="Times New Roman" pitchFamily="18" charset="0"/>
              </a:rPr>
              <a:t>TWIST1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(-)</a:t>
            </a:r>
          </a:p>
        </p:txBody>
      </p:sp>
      <p:sp>
        <p:nvSpPr>
          <p:cNvPr id="70" name="24 - TextBox"/>
          <p:cNvSpPr txBox="1"/>
          <p:nvPr/>
        </p:nvSpPr>
        <p:spPr>
          <a:xfrm>
            <a:off x="7974457" y="2576326"/>
            <a:ext cx="171451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>
                <a:latin typeface="Times New Roman" pitchFamily="18" charset="0"/>
                <a:cs typeface="Times New Roman" pitchFamily="18" charset="0"/>
              </a:rPr>
              <a:t>LN(+), </a:t>
            </a:r>
            <a:r>
              <a:rPr lang="en-US" sz="750" i="1" dirty="0">
                <a:latin typeface="Times New Roman" pitchFamily="18" charset="0"/>
                <a:cs typeface="Times New Roman" pitchFamily="18" charset="0"/>
              </a:rPr>
              <a:t>TWIST1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(-)</a:t>
            </a:r>
          </a:p>
        </p:txBody>
      </p:sp>
      <p:sp>
        <p:nvSpPr>
          <p:cNvPr id="71" name="24 - TextBox"/>
          <p:cNvSpPr txBox="1"/>
          <p:nvPr/>
        </p:nvSpPr>
        <p:spPr>
          <a:xfrm>
            <a:off x="7731960" y="3015309"/>
            <a:ext cx="171451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>
                <a:latin typeface="Times New Roman" pitchFamily="18" charset="0"/>
                <a:cs typeface="Times New Roman" pitchFamily="18" charset="0"/>
              </a:rPr>
              <a:t>LN(-), </a:t>
            </a:r>
            <a:r>
              <a:rPr lang="en-US" sz="750" i="1" dirty="0">
                <a:latin typeface="Times New Roman" pitchFamily="18" charset="0"/>
                <a:cs typeface="Times New Roman" pitchFamily="18" charset="0"/>
              </a:rPr>
              <a:t>TWIST1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75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72" name="24 - TextBox"/>
          <p:cNvSpPr txBox="1"/>
          <p:nvPr/>
        </p:nvSpPr>
        <p:spPr>
          <a:xfrm>
            <a:off x="7359698" y="3395295"/>
            <a:ext cx="171451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>
                <a:latin typeface="Times New Roman" pitchFamily="18" charset="0"/>
                <a:cs typeface="Times New Roman" pitchFamily="18" charset="0"/>
              </a:rPr>
              <a:t>LN(+), </a:t>
            </a:r>
            <a:r>
              <a:rPr lang="en-US" sz="750" i="1" dirty="0">
                <a:latin typeface="Times New Roman" pitchFamily="18" charset="0"/>
                <a:cs typeface="Times New Roman" pitchFamily="18" charset="0"/>
              </a:rPr>
              <a:t>TWIST1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75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l-GR" sz="750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101" name="13 - TextBox"/>
          <p:cNvSpPr txBox="1"/>
          <p:nvPr/>
        </p:nvSpPr>
        <p:spPr>
          <a:xfrm>
            <a:off x="0" y="128789"/>
            <a:ext cx="23574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Suppl. Figure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3</a:t>
            </a:r>
            <a:endParaRPr lang="el-GR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7112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86</Words>
  <Application>Microsoft Office PowerPoint</Application>
  <PresentationFormat>On-screen Show (4:3)</PresentationFormat>
  <Paragraphs>3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eti Strati</dc:creator>
  <cp:lastModifiedBy>Areti Strati</cp:lastModifiedBy>
  <cp:revision>3</cp:revision>
  <dcterms:created xsi:type="dcterms:W3CDTF">2019-02-19T16:30:49Z</dcterms:created>
  <dcterms:modified xsi:type="dcterms:W3CDTF">2019-05-14T11:36:58Z</dcterms:modified>
</cp:coreProperties>
</file>